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867"/>
    <p:restoredTop sz="94604"/>
  </p:normalViewPr>
  <p:slideViewPr>
    <p:cSldViewPr snapToGrid="0" snapToObjects="1">
      <p:cViewPr varScale="1">
        <p:scale>
          <a:sx n="150" d="100"/>
          <a:sy n="150" d="100"/>
        </p:scale>
        <p:origin x="1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B5667-B054-754E-A456-39F643E01E0D}" type="datetimeFigureOut">
              <a:rPr lang="en-US" smtClean="0"/>
              <a:t>4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56A26-9EF8-7E4A-BF99-95EC618A7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02776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B5667-B054-754E-A456-39F643E01E0D}" type="datetimeFigureOut">
              <a:rPr lang="en-US" smtClean="0"/>
              <a:t>4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56A26-9EF8-7E4A-BF99-95EC618A7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6003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B5667-B054-754E-A456-39F643E01E0D}" type="datetimeFigureOut">
              <a:rPr lang="en-US" smtClean="0"/>
              <a:t>4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56A26-9EF8-7E4A-BF99-95EC618A7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74090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B5667-B054-754E-A456-39F643E01E0D}" type="datetimeFigureOut">
              <a:rPr lang="en-US" smtClean="0"/>
              <a:t>4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56A26-9EF8-7E4A-BF99-95EC618A7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6342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B5667-B054-754E-A456-39F643E01E0D}" type="datetimeFigureOut">
              <a:rPr lang="en-US" smtClean="0"/>
              <a:t>4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56A26-9EF8-7E4A-BF99-95EC618A7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3496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B5667-B054-754E-A456-39F643E01E0D}" type="datetimeFigureOut">
              <a:rPr lang="en-US" smtClean="0"/>
              <a:t>4/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56A26-9EF8-7E4A-BF99-95EC618A7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20607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B5667-B054-754E-A456-39F643E01E0D}" type="datetimeFigureOut">
              <a:rPr lang="en-US" smtClean="0"/>
              <a:t>4/9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56A26-9EF8-7E4A-BF99-95EC618A7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59992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B5667-B054-754E-A456-39F643E01E0D}" type="datetimeFigureOut">
              <a:rPr lang="en-US" smtClean="0"/>
              <a:t>4/9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56A26-9EF8-7E4A-BF99-95EC618A7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21062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B5667-B054-754E-A456-39F643E01E0D}" type="datetimeFigureOut">
              <a:rPr lang="en-US" smtClean="0"/>
              <a:t>4/9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56A26-9EF8-7E4A-BF99-95EC618A7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59629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B5667-B054-754E-A456-39F643E01E0D}" type="datetimeFigureOut">
              <a:rPr lang="en-US" smtClean="0"/>
              <a:t>4/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56A26-9EF8-7E4A-BF99-95EC618A7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815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8B5667-B054-754E-A456-39F643E01E0D}" type="datetimeFigureOut">
              <a:rPr lang="en-US" smtClean="0"/>
              <a:t>4/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56A26-9EF8-7E4A-BF99-95EC618A7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45757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8B5667-B054-754E-A456-39F643E01E0D}" type="datetimeFigureOut">
              <a:rPr lang="en-US" smtClean="0"/>
              <a:t>4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856A26-9EF8-7E4A-BF99-95EC618A7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23697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" name="TextBox 142">
            <a:extLst>
              <a:ext uri="{FF2B5EF4-FFF2-40B4-BE49-F238E27FC236}">
                <a16:creationId xmlns:a16="http://schemas.microsoft.com/office/drawing/2014/main" id="{286BE662-B0D4-534A-B43E-0115804EED5C}"/>
              </a:ext>
            </a:extLst>
          </p:cNvPr>
          <p:cNvSpPr txBox="1"/>
          <p:nvPr/>
        </p:nvSpPr>
        <p:spPr>
          <a:xfrm>
            <a:off x="92317" y="1898286"/>
            <a:ext cx="6714035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. </a:t>
            </a:r>
            <a:r>
              <a:rPr lang="en-US" sz="11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rimary images for Figure 6C. 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Western blot images supporting quantification of H358 tumor xenografts treated in vivo with erlotinib (10 mg/kg), alisertib (10 mg/kg), or both for 6 or 24 hours as indicated, supporting quantitation shown in Figure 6C.  Note, because tumors were collected at ~ 150 mm</a:t>
            </a:r>
            <a:r>
              <a:rPr lang="en-US" sz="11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3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following single dosing, and because H358 tumors consistently had extensive necrotic areas, very little protein lysate was obtained, limiting sample for Western analysis. 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agnyukova </a:t>
            </a:r>
            <a:r>
              <a:rPr lang="en-U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et al.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B98B2405-E37B-1DFA-561F-2F0A390A541A}"/>
              </a:ext>
            </a:extLst>
          </p:cNvPr>
          <p:cNvGrpSpPr/>
          <p:nvPr/>
        </p:nvGrpSpPr>
        <p:grpSpPr>
          <a:xfrm>
            <a:off x="511688" y="211192"/>
            <a:ext cx="5720840" cy="1301419"/>
            <a:chOff x="511688" y="211192"/>
            <a:chExt cx="5720840" cy="1301419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202ADBD6-AD0D-0D66-44F6-C9082E213AF2}"/>
                </a:ext>
              </a:extLst>
            </p:cNvPr>
            <p:cNvSpPr txBox="1"/>
            <p:nvPr/>
          </p:nvSpPr>
          <p:spPr>
            <a:xfrm>
              <a:off x="647392" y="762590"/>
              <a:ext cx="96693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pEGFR-Tyr</a:t>
              </a:r>
              <a:r>
                <a:rPr lang="en-US" sz="9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068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3CC4CB4D-54FE-CD1A-2EA8-6C49E9800151}"/>
                </a:ext>
              </a:extLst>
            </p:cNvPr>
            <p:cNvSpPr txBox="1"/>
            <p:nvPr/>
          </p:nvSpPr>
          <p:spPr>
            <a:xfrm>
              <a:off x="1091287" y="1017597"/>
              <a:ext cx="50526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EGFR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D0877F36-5A0A-1426-97F4-62A89D9166E1}"/>
                </a:ext>
              </a:extLst>
            </p:cNvPr>
            <p:cNvSpPr txBox="1"/>
            <p:nvPr/>
          </p:nvSpPr>
          <p:spPr>
            <a:xfrm>
              <a:off x="959691" y="1281779"/>
              <a:ext cx="6591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vimentin</a:t>
              </a:r>
            </a:p>
          </p:txBody>
        </p: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89B677C0-FD85-C740-4C1C-9CB3DFC93400}"/>
                </a:ext>
              </a:extLst>
            </p:cNvPr>
            <p:cNvCxnSpPr/>
            <p:nvPr/>
          </p:nvCxnSpPr>
          <p:spPr>
            <a:xfrm>
              <a:off x="1591240" y="711915"/>
              <a:ext cx="73152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489A8A8A-7D43-F014-BE86-C88556507266}"/>
                </a:ext>
              </a:extLst>
            </p:cNvPr>
            <p:cNvCxnSpPr/>
            <p:nvPr/>
          </p:nvCxnSpPr>
          <p:spPr>
            <a:xfrm>
              <a:off x="2366887" y="712926"/>
              <a:ext cx="50292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41D9A26D-6C76-504F-8C36-932899BD5199}"/>
                </a:ext>
              </a:extLst>
            </p:cNvPr>
            <p:cNvCxnSpPr/>
            <p:nvPr/>
          </p:nvCxnSpPr>
          <p:spPr>
            <a:xfrm>
              <a:off x="4360929" y="701622"/>
              <a:ext cx="45720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88D02384-1D6C-0649-33BD-997D78644EDE}"/>
                </a:ext>
              </a:extLst>
            </p:cNvPr>
            <p:cNvSpPr txBox="1"/>
            <p:nvPr/>
          </p:nvSpPr>
          <p:spPr>
            <a:xfrm>
              <a:off x="1407749" y="341437"/>
              <a:ext cx="453051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Vehicle                        6 h                                                     24 h</a:t>
              </a:r>
            </a:p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          E             A            EA                      E            A            EA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E4E839C-26B7-A658-682F-637CCCDA1B73}"/>
                </a:ext>
              </a:extLst>
            </p:cNvPr>
            <p:cNvSpPr txBox="1"/>
            <p:nvPr/>
          </p:nvSpPr>
          <p:spPr>
            <a:xfrm>
              <a:off x="511688" y="211192"/>
              <a:ext cx="5501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C00000"/>
                  </a:solidFill>
                  <a:latin typeface="Arial"/>
                  <a:cs typeface="Arial"/>
                </a:rPr>
                <a:t>H358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4104087-A12F-6B84-705E-725ACC7C9727}"/>
                </a:ext>
              </a:extLst>
            </p:cNvPr>
            <p:cNvSpPr txBox="1"/>
            <p:nvPr/>
          </p:nvSpPr>
          <p:spPr>
            <a:xfrm>
              <a:off x="5842678" y="997394"/>
              <a:ext cx="3898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 160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50420A6C-88F4-64DB-D65E-B10C9929BABB}"/>
                </a:ext>
              </a:extLst>
            </p:cNvPr>
            <p:cNvSpPr txBox="1"/>
            <p:nvPr/>
          </p:nvSpPr>
          <p:spPr>
            <a:xfrm>
              <a:off x="5841831" y="741248"/>
              <a:ext cx="3898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 160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F7D8952F-22F6-D6E2-665F-D59ED375CD14}"/>
                </a:ext>
              </a:extLst>
            </p:cNvPr>
            <p:cNvSpPr txBox="1"/>
            <p:nvPr/>
          </p:nvSpPr>
          <p:spPr>
            <a:xfrm>
              <a:off x="5842678" y="1209632"/>
              <a:ext cx="3401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 60</a:t>
              </a:r>
            </a:p>
          </p:txBody>
        </p:sp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6E083ABB-43F9-C716-9299-32EDFFFBDC67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" cstate="hq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3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568223" y="751895"/>
              <a:ext cx="2468880" cy="228600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852A3E9B-E6BB-6DE2-9629-8540472A788E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" cstate="hq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3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326571" y="739605"/>
              <a:ext cx="1600200" cy="228600"/>
            </a:xfrm>
            <a:prstGeom prst="rect">
              <a:avLst/>
            </a:prstGeom>
          </p:spPr>
        </p:pic>
        <p:pic>
          <p:nvPicPr>
            <p:cNvPr id="78" name="Picture 77">
              <a:extLst>
                <a:ext uri="{FF2B5EF4-FFF2-40B4-BE49-F238E27FC236}">
                  <a16:creationId xmlns:a16="http://schemas.microsoft.com/office/drawing/2014/main" id="{EE46E9D9-7C44-23C9-E0EF-6E92C9420074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6" cstate="hq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35000"/>
                      </a14:imgEffect>
                      <a14:imgEffect>
                        <a14:brightnessContrast contrast="3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568223" y="1023300"/>
              <a:ext cx="2468880" cy="228600"/>
            </a:xfrm>
            <a:prstGeom prst="rect">
              <a:avLst/>
            </a:prstGeom>
          </p:spPr>
        </p:pic>
        <p:pic>
          <p:nvPicPr>
            <p:cNvPr id="79" name="Picture 78">
              <a:extLst>
                <a:ext uri="{FF2B5EF4-FFF2-40B4-BE49-F238E27FC236}">
                  <a16:creationId xmlns:a16="http://schemas.microsoft.com/office/drawing/2014/main" id="{4EE5E1BB-1938-8D3D-E023-56B7F43BE5D9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8" cstate="hq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harpenSoften amount="61000"/>
                      </a14:imgEffect>
                      <a14:imgEffect>
                        <a14:brightnessContrast contrast="3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326571" y="1014925"/>
              <a:ext cx="1600200" cy="228600"/>
            </a:xfrm>
            <a:prstGeom prst="rect">
              <a:avLst/>
            </a:prstGeom>
          </p:spPr>
        </p:pic>
        <p:pic>
          <p:nvPicPr>
            <p:cNvPr id="80" name="Picture 79">
              <a:extLst>
                <a:ext uri="{FF2B5EF4-FFF2-40B4-BE49-F238E27FC236}">
                  <a16:creationId xmlns:a16="http://schemas.microsoft.com/office/drawing/2014/main" id="{BD748A57-27F2-0F4B-3D75-28AAB2FE4CA6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0" cstate="hq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552431" y="1278307"/>
              <a:ext cx="2468880" cy="228600"/>
            </a:xfrm>
            <a:prstGeom prst="rect">
              <a:avLst/>
            </a:prstGeom>
          </p:spPr>
        </p:pic>
        <p:pic>
          <p:nvPicPr>
            <p:cNvPr id="82" name="Picture 81">
              <a:extLst>
                <a:ext uri="{FF2B5EF4-FFF2-40B4-BE49-F238E27FC236}">
                  <a16:creationId xmlns:a16="http://schemas.microsoft.com/office/drawing/2014/main" id="{5A532F62-A103-8163-0B2B-9DBA1E1C56E8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2" cstate="hq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326571" y="1278307"/>
              <a:ext cx="1600200" cy="228600"/>
            </a:xfrm>
            <a:prstGeom prst="rect">
              <a:avLst/>
            </a:prstGeom>
          </p:spPr>
        </p:pic>
        <p:cxnSp>
          <p:nvCxnSpPr>
            <p:cNvPr id="2" name="Straight Connector 1">
              <a:extLst>
                <a:ext uri="{FF2B5EF4-FFF2-40B4-BE49-F238E27FC236}">
                  <a16:creationId xmlns:a16="http://schemas.microsoft.com/office/drawing/2014/main" id="{ED718DE1-D3E9-A81E-9563-DA952A28A6A1}"/>
                </a:ext>
              </a:extLst>
            </p:cNvPr>
            <p:cNvCxnSpPr/>
            <p:nvPr/>
          </p:nvCxnSpPr>
          <p:spPr>
            <a:xfrm>
              <a:off x="2930412" y="709385"/>
              <a:ext cx="50292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" name="Straight Connector 2">
              <a:extLst>
                <a:ext uri="{FF2B5EF4-FFF2-40B4-BE49-F238E27FC236}">
                  <a16:creationId xmlns:a16="http://schemas.microsoft.com/office/drawing/2014/main" id="{C7293418-7B67-4952-3AFD-2541A43A3D6D}"/>
                </a:ext>
              </a:extLst>
            </p:cNvPr>
            <p:cNvCxnSpPr/>
            <p:nvPr/>
          </p:nvCxnSpPr>
          <p:spPr>
            <a:xfrm>
              <a:off x="3508110" y="712926"/>
              <a:ext cx="50292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Straight Connector 4">
              <a:extLst>
                <a:ext uri="{FF2B5EF4-FFF2-40B4-BE49-F238E27FC236}">
                  <a16:creationId xmlns:a16="http://schemas.microsoft.com/office/drawing/2014/main" id="{C888A329-1927-FC64-FD5D-2A107C2A7742}"/>
                </a:ext>
              </a:extLst>
            </p:cNvPr>
            <p:cNvCxnSpPr/>
            <p:nvPr/>
          </p:nvCxnSpPr>
          <p:spPr>
            <a:xfrm>
              <a:off x="4867744" y="698081"/>
              <a:ext cx="45720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44B62719-C904-6459-26AC-3C25EF13313B}"/>
                </a:ext>
              </a:extLst>
            </p:cNvPr>
            <p:cNvCxnSpPr/>
            <p:nvPr/>
          </p:nvCxnSpPr>
          <p:spPr>
            <a:xfrm>
              <a:off x="5413550" y="698079"/>
              <a:ext cx="45720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6590960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511</TotalTime>
  <Words>118</Words>
  <Application>Microsoft Macintosh PowerPoint</Application>
  <PresentationFormat>Letter Paper (8.5x11 in)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gnyukova, Tetyana V.</dc:creator>
  <cp:lastModifiedBy>Bagnyukova, Tetyana V.</cp:lastModifiedBy>
  <cp:revision>90</cp:revision>
  <cp:lastPrinted>2023-06-13T20:23:05Z</cp:lastPrinted>
  <dcterms:created xsi:type="dcterms:W3CDTF">2022-01-14T20:51:39Z</dcterms:created>
  <dcterms:modified xsi:type="dcterms:W3CDTF">2024-04-09T15:52:54Z</dcterms:modified>
</cp:coreProperties>
</file>